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321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395CB-14BC-44EC-83B8-A42BE92AAD48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2BA10-0F0E-4219-9C47-EFE67EECD1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7736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395CB-14BC-44EC-83B8-A42BE92AAD48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2BA10-0F0E-4219-9C47-EFE67EECD1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2214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395CB-14BC-44EC-83B8-A42BE92AAD48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2BA10-0F0E-4219-9C47-EFE67EECD1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9129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395CB-14BC-44EC-83B8-A42BE92AAD48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2BA10-0F0E-4219-9C47-EFE67EECD1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0587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395CB-14BC-44EC-83B8-A42BE92AAD48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2BA10-0F0E-4219-9C47-EFE67EECD1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2690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395CB-14BC-44EC-83B8-A42BE92AAD48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2BA10-0F0E-4219-9C47-EFE67EECD1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4632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395CB-14BC-44EC-83B8-A42BE92AAD48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2BA10-0F0E-4219-9C47-EFE67EECD1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5481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395CB-14BC-44EC-83B8-A42BE92AAD48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2BA10-0F0E-4219-9C47-EFE67EECD1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7703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395CB-14BC-44EC-83B8-A42BE92AAD48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2BA10-0F0E-4219-9C47-EFE67EECD1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241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395CB-14BC-44EC-83B8-A42BE92AAD48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2BA10-0F0E-4219-9C47-EFE67EECD1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3138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395CB-14BC-44EC-83B8-A42BE92AAD48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62BA10-0F0E-4219-9C47-EFE67EECD1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0397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6395CB-14BC-44EC-83B8-A42BE92AAD48}" type="datetimeFigureOut">
              <a:rPr kumimoji="1" lang="ja-JP" altLang="en-US" smtClean="0"/>
              <a:t>2025/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62BA10-0F0E-4219-9C47-EFE67EECD1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1908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DD3625F-8EED-4CA4-0648-B394D1C015E3}"/>
              </a:ext>
            </a:extLst>
          </p:cNvPr>
          <p:cNvSpPr txBox="1"/>
          <p:nvPr/>
        </p:nvSpPr>
        <p:spPr>
          <a:xfrm>
            <a:off x="538273" y="525667"/>
            <a:ext cx="57814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l-PL" altLang="ja-JP" sz="18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Figure</a:t>
            </a:r>
            <a:r>
              <a:rPr lang="pl-PL" altLang="ja-JP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S</a:t>
            </a:r>
            <a:r>
              <a:rPr lang="en-US" altLang="ja-JP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1.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The</a:t>
            </a:r>
            <a:r>
              <a:rPr lang="ja-JP" altLang="en-US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detailing the diagnosis of each tooth</a:t>
            </a:r>
            <a:endParaRPr lang="ja-JP" altLang="ja-JP" sz="180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61FE8F0A-743D-0FDF-28F2-45A1905566A6}"/>
              </a:ext>
            </a:extLst>
          </p:cNvPr>
          <p:cNvCxnSpPr/>
          <p:nvPr/>
        </p:nvCxnSpPr>
        <p:spPr>
          <a:xfrm>
            <a:off x="1075977" y="2103599"/>
            <a:ext cx="453600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BBDF91FB-E736-B596-5CC7-392A0A92A5AF}"/>
              </a:ext>
            </a:extLst>
          </p:cNvPr>
          <p:cNvGrpSpPr/>
          <p:nvPr/>
        </p:nvGrpSpPr>
        <p:grpSpPr>
          <a:xfrm>
            <a:off x="746957" y="1279046"/>
            <a:ext cx="5364083" cy="1649105"/>
            <a:chOff x="661785" y="1285396"/>
            <a:chExt cx="5364083" cy="1649105"/>
          </a:xfrm>
        </p:grpSpPr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C0F000FC-7C42-2164-89D8-668998FF3A32}"/>
                </a:ext>
              </a:extLst>
            </p:cNvPr>
            <p:cNvCxnSpPr/>
            <p:nvPr/>
          </p:nvCxnSpPr>
          <p:spPr>
            <a:xfrm>
              <a:off x="3343826" y="1285396"/>
              <a:ext cx="0" cy="1649105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A87BC1EF-A2BE-6F71-7BDF-C5E7CAB75126}"/>
                </a:ext>
              </a:extLst>
            </p:cNvPr>
            <p:cNvSpPr txBox="1"/>
            <p:nvPr/>
          </p:nvSpPr>
          <p:spPr>
            <a:xfrm>
              <a:off x="661785" y="1684247"/>
              <a:ext cx="5364083" cy="8540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E</a:t>
              </a:r>
              <a:r>
                <a:rPr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D</a:t>
              </a:r>
              <a:r>
                <a:rPr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C</a:t>
              </a:r>
              <a:r>
                <a:rPr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B</a:t>
              </a:r>
              <a:r>
                <a:rPr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A </a:t>
              </a:r>
              <a:r>
                <a:rPr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 </a:t>
              </a:r>
              <a:r>
                <a:rPr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A</a:t>
              </a:r>
              <a:r>
                <a:rPr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B</a:t>
              </a:r>
              <a:r>
                <a:rPr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kumimoji="1"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C</a:t>
              </a:r>
              <a:r>
                <a:rPr kumimoji="1"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kumimoji="1"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D</a:t>
              </a:r>
              <a:r>
                <a:rPr kumimoji="1"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kumimoji="1"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E</a:t>
              </a:r>
            </a:p>
            <a:p>
              <a:pPr algn="ctr"/>
              <a:endParaRPr kumimoji="1" lang="en-US" altLang="ja-JP" sz="1050" dirty="0">
                <a:latin typeface="Century" panose="02040604050505020304" pitchFamily="18" charset="0"/>
                <a:cs typeface="Helvetica" panose="020B0604020202020204" pitchFamily="34" charset="0"/>
              </a:endParaRPr>
            </a:p>
            <a:p>
              <a:pPr algn="ctr"/>
              <a:r>
                <a:rPr kumimoji="1"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E</a:t>
              </a:r>
              <a:r>
                <a:rPr kumimoji="1"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kumimoji="1"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D</a:t>
              </a:r>
              <a:r>
                <a:rPr kumimoji="1"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kumimoji="1"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C</a:t>
              </a:r>
              <a:r>
                <a:rPr kumimoji="1"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kumimoji="1"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B</a:t>
              </a:r>
              <a:r>
                <a:rPr kumimoji="1"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kumimoji="1"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A </a:t>
              </a:r>
              <a:r>
                <a:rPr kumimoji="1"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 </a:t>
              </a:r>
              <a:r>
                <a:rPr kumimoji="1"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A</a:t>
              </a:r>
              <a:r>
                <a:rPr kumimoji="1"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kumimoji="1"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B</a:t>
              </a:r>
              <a:r>
                <a:rPr kumimoji="1"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kumimoji="1"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C</a:t>
              </a:r>
              <a:r>
                <a:rPr kumimoji="1"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kumimoji="1"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D</a:t>
              </a:r>
              <a:r>
                <a:rPr kumimoji="1"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</a:t>
              </a:r>
              <a:r>
                <a:rPr kumimoji="1" lang="en-US" altLang="ja-JP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E</a:t>
              </a:r>
              <a:r>
                <a:rPr kumimoji="1" lang="ja-JP" altLang="en-US" sz="1950" dirty="0">
                  <a:latin typeface="Century" panose="02040604050505020304" pitchFamily="18" charset="0"/>
                  <a:cs typeface="Helvetica" panose="020B0604020202020204" pitchFamily="34" charset="0"/>
                </a:rPr>
                <a:t>　  </a:t>
              </a:r>
            </a:p>
          </p:txBody>
        </p:sp>
        <p:pic>
          <p:nvPicPr>
            <p:cNvPr id="12" name="Picture 2">
              <a:extLst>
                <a:ext uri="{FF2B5EF4-FFF2-40B4-BE49-F238E27FC236}">
                  <a16:creationId xmlns:a16="http://schemas.microsoft.com/office/drawing/2014/main" id="{A3B55478-5790-923D-541D-50484BC590C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31" t="-5804" r="33106" b="66826"/>
            <a:stretch/>
          </p:blipFill>
          <p:spPr bwMode="auto">
            <a:xfrm>
              <a:off x="1145727" y="2430061"/>
              <a:ext cx="2160000" cy="4118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" name="Picture 2">
              <a:extLst>
                <a:ext uri="{FF2B5EF4-FFF2-40B4-BE49-F238E27FC236}">
                  <a16:creationId xmlns:a16="http://schemas.microsoft.com/office/drawing/2014/main" id="{E9EEB977-D43D-E4DE-61E2-470AED3689A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31" t="-5804" r="33106" b="66826"/>
            <a:stretch/>
          </p:blipFill>
          <p:spPr bwMode="auto">
            <a:xfrm>
              <a:off x="3387600" y="2419428"/>
              <a:ext cx="2160000" cy="4118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2">
              <a:extLst>
                <a:ext uri="{FF2B5EF4-FFF2-40B4-BE49-F238E27FC236}">
                  <a16:creationId xmlns:a16="http://schemas.microsoft.com/office/drawing/2014/main" id="{047E1D27-E700-053B-4850-EAD44B40B55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31" t="-5804" r="33106" b="66826"/>
            <a:stretch/>
          </p:blipFill>
          <p:spPr bwMode="auto">
            <a:xfrm>
              <a:off x="1144800" y="1313790"/>
              <a:ext cx="2160000" cy="4118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2">
              <a:extLst>
                <a:ext uri="{FF2B5EF4-FFF2-40B4-BE49-F238E27FC236}">
                  <a16:creationId xmlns:a16="http://schemas.microsoft.com/office/drawing/2014/main" id="{58601754-5A7C-4F18-EBDE-6B888580156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31" t="-5804" r="33106" b="66826"/>
            <a:stretch/>
          </p:blipFill>
          <p:spPr bwMode="auto">
            <a:xfrm>
              <a:off x="3388450" y="1297169"/>
              <a:ext cx="2160000" cy="4118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3B26236-4B8B-3A08-9967-BAFC4F2EFA51}"/>
              </a:ext>
            </a:extLst>
          </p:cNvPr>
          <p:cNvSpPr txBox="1"/>
          <p:nvPr/>
        </p:nvSpPr>
        <p:spPr>
          <a:xfrm>
            <a:off x="870981" y="3353853"/>
            <a:ext cx="511603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The black parts indicate caries of more than C2 [35].</a:t>
            </a:r>
            <a:endParaRPr lang="ja-JP" altLang="en-US" dirty="0"/>
          </a:p>
        </p:txBody>
      </p:sp>
      <p:sp>
        <p:nvSpPr>
          <p:cNvPr id="19" name="楕円 18">
            <a:extLst>
              <a:ext uri="{FF2B5EF4-FFF2-40B4-BE49-F238E27FC236}">
                <a16:creationId xmlns:a16="http://schemas.microsoft.com/office/drawing/2014/main" id="{BD3BF75B-2F35-D179-C2E1-1414AFB0F713}"/>
              </a:ext>
            </a:extLst>
          </p:cNvPr>
          <p:cNvSpPr/>
          <p:nvPr/>
        </p:nvSpPr>
        <p:spPr>
          <a:xfrm>
            <a:off x="2106490" y="1379673"/>
            <a:ext cx="398318" cy="32499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楕円 21">
            <a:extLst>
              <a:ext uri="{FF2B5EF4-FFF2-40B4-BE49-F238E27FC236}">
                <a16:creationId xmlns:a16="http://schemas.microsoft.com/office/drawing/2014/main" id="{091D8E28-65D8-2095-F6B4-05C5C01D9582}"/>
              </a:ext>
            </a:extLst>
          </p:cNvPr>
          <p:cNvSpPr/>
          <p:nvPr/>
        </p:nvSpPr>
        <p:spPr>
          <a:xfrm>
            <a:off x="2553539" y="1374357"/>
            <a:ext cx="398318" cy="32499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楕円 22">
            <a:extLst>
              <a:ext uri="{FF2B5EF4-FFF2-40B4-BE49-F238E27FC236}">
                <a16:creationId xmlns:a16="http://schemas.microsoft.com/office/drawing/2014/main" id="{87C318B6-02D1-A0E2-3E3F-B94827D5B378}"/>
              </a:ext>
            </a:extLst>
          </p:cNvPr>
          <p:cNvSpPr/>
          <p:nvPr/>
        </p:nvSpPr>
        <p:spPr>
          <a:xfrm>
            <a:off x="2981200" y="1372495"/>
            <a:ext cx="398318" cy="32499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楕円 23">
            <a:extLst>
              <a:ext uri="{FF2B5EF4-FFF2-40B4-BE49-F238E27FC236}">
                <a16:creationId xmlns:a16="http://schemas.microsoft.com/office/drawing/2014/main" id="{5F235A06-E230-76D2-9475-EBBD43E43E17}"/>
              </a:ext>
            </a:extLst>
          </p:cNvPr>
          <p:cNvSpPr/>
          <p:nvPr/>
        </p:nvSpPr>
        <p:spPr>
          <a:xfrm>
            <a:off x="3497584" y="1367179"/>
            <a:ext cx="398318" cy="32499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楕円 24">
            <a:extLst>
              <a:ext uri="{FF2B5EF4-FFF2-40B4-BE49-F238E27FC236}">
                <a16:creationId xmlns:a16="http://schemas.microsoft.com/office/drawing/2014/main" id="{CE2C5D0F-2916-193B-C4A8-E7D06E76266D}"/>
              </a:ext>
            </a:extLst>
          </p:cNvPr>
          <p:cNvSpPr/>
          <p:nvPr/>
        </p:nvSpPr>
        <p:spPr>
          <a:xfrm>
            <a:off x="3923011" y="1356946"/>
            <a:ext cx="398318" cy="32499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楕円 25">
            <a:extLst>
              <a:ext uri="{FF2B5EF4-FFF2-40B4-BE49-F238E27FC236}">
                <a16:creationId xmlns:a16="http://schemas.microsoft.com/office/drawing/2014/main" id="{BA76BA36-B491-D2F7-6C02-3997725CEE68}"/>
              </a:ext>
            </a:extLst>
          </p:cNvPr>
          <p:cNvSpPr/>
          <p:nvPr/>
        </p:nvSpPr>
        <p:spPr>
          <a:xfrm>
            <a:off x="4353613" y="1367179"/>
            <a:ext cx="398318" cy="324990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28" name="図 27">
            <a:extLst>
              <a:ext uri="{FF2B5EF4-FFF2-40B4-BE49-F238E27FC236}">
                <a16:creationId xmlns:a16="http://schemas.microsoft.com/office/drawing/2014/main" id="{C9DDB199-E195-2925-08DF-03A3EF622EC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70193" b="1492"/>
          <a:stretch/>
        </p:blipFill>
        <p:spPr>
          <a:xfrm>
            <a:off x="4796554" y="1357286"/>
            <a:ext cx="119934" cy="318298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8D0F08FE-DEB9-7946-9660-6A7B13B093A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 rot="10800000">
            <a:off x="1952625" y="1386665"/>
            <a:ext cx="124735" cy="318298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02F66CA7-4A8C-2676-212F-D66CEAA3013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-1" t="63867" r="-4263" b="1490"/>
          <a:stretch/>
        </p:blipFill>
        <p:spPr>
          <a:xfrm rot="10800000">
            <a:off x="1231644" y="1388252"/>
            <a:ext cx="419538" cy="111935"/>
          </a:xfrm>
          <a:prstGeom prst="rect">
            <a:avLst/>
          </a:prstGeom>
        </p:spPr>
      </p:pic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76D53629-8EFF-BF69-B457-FF9851761345}"/>
              </a:ext>
            </a:extLst>
          </p:cNvPr>
          <p:cNvSpPr/>
          <p:nvPr/>
        </p:nvSpPr>
        <p:spPr>
          <a:xfrm>
            <a:off x="1376483" y="1487716"/>
            <a:ext cx="157041" cy="9805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0687F869-D39D-5422-86C9-BEA68C0C48CC}"/>
              </a:ext>
            </a:extLst>
          </p:cNvPr>
          <p:cNvSpPr/>
          <p:nvPr/>
        </p:nvSpPr>
        <p:spPr>
          <a:xfrm>
            <a:off x="1808020" y="1487715"/>
            <a:ext cx="157041" cy="972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525C8BFD-03FB-AAA3-3D53-BFFA4513BD83}"/>
              </a:ext>
            </a:extLst>
          </p:cNvPr>
          <p:cNvSpPr/>
          <p:nvPr/>
        </p:nvSpPr>
        <p:spPr>
          <a:xfrm>
            <a:off x="4903330" y="1468822"/>
            <a:ext cx="157041" cy="972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36" name="図 35">
            <a:extLst>
              <a:ext uri="{FF2B5EF4-FFF2-40B4-BE49-F238E27FC236}">
                <a16:creationId xmlns:a16="http://schemas.microsoft.com/office/drawing/2014/main" id="{FC152BA5-5987-72B8-35AA-D7020001DA5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b="66078"/>
          <a:stretch/>
        </p:blipFill>
        <p:spPr>
          <a:xfrm>
            <a:off x="4792223" y="1354834"/>
            <a:ext cx="402371" cy="111675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0B1B06CF-F0F2-46C4-9EC2-A1D2610CBCD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19481" y="1350972"/>
            <a:ext cx="402371" cy="213378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E9D9C527-3FAF-4CAD-AC8A-D786A39EC5B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 rot="10800000">
            <a:off x="3238013" y="2492969"/>
            <a:ext cx="136488" cy="318298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84729E06-D325-B2D8-B59A-08A0FF3618F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>
            <a:off x="2975939" y="2487953"/>
            <a:ext cx="136488" cy="318298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FC260E1A-4352-97E7-50DC-02F4C9909D3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 rot="10800000">
            <a:off x="3759829" y="2494526"/>
            <a:ext cx="136488" cy="318298"/>
          </a:xfrm>
          <a:prstGeom prst="rect">
            <a:avLst/>
          </a:prstGeom>
        </p:spPr>
      </p:pic>
      <p:pic>
        <p:nvPicPr>
          <p:cNvPr id="41" name="図 40">
            <a:extLst>
              <a:ext uri="{FF2B5EF4-FFF2-40B4-BE49-F238E27FC236}">
                <a16:creationId xmlns:a16="http://schemas.microsoft.com/office/drawing/2014/main" id="{6091CE8C-C828-7C3B-6E76-DAECBAC97E3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>
            <a:off x="3496083" y="2489510"/>
            <a:ext cx="136488" cy="318298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D037A4FD-7794-CFE8-FE90-9543B984E7B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 rot="10800000">
            <a:off x="4183373" y="2492464"/>
            <a:ext cx="136488" cy="318298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92899A95-D305-B11F-9AAF-001774DE6A5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>
            <a:off x="3919627" y="2487448"/>
            <a:ext cx="136488" cy="318298"/>
          </a:xfrm>
          <a:prstGeom prst="rect">
            <a:avLst/>
          </a:prstGeom>
        </p:spPr>
      </p:pic>
      <p:pic>
        <p:nvPicPr>
          <p:cNvPr id="45" name="図 44">
            <a:extLst>
              <a:ext uri="{FF2B5EF4-FFF2-40B4-BE49-F238E27FC236}">
                <a16:creationId xmlns:a16="http://schemas.microsoft.com/office/drawing/2014/main" id="{E9F6C41A-01A6-8370-3AF2-D3224A0C0930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30856" b="-1"/>
          <a:stretch/>
        </p:blipFill>
        <p:spPr>
          <a:xfrm>
            <a:off x="3917078" y="2589407"/>
            <a:ext cx="396274" cy="223417"/>
          </a:xfrm>
          <a:prstGeom prst="rect">
            <a:avLst/>
          </a:prstGeom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id="{AE062C73-B22D-E2C3-5ECB-0EAF92226056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60797"/>
          <a:stretch/>
        </p:blipFill>
        <p:spPr>
          <a:xfrm>
            <a:off x="2550195" y="2694722"/>
            <a:ext cx="396274" cy="126672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id="{B20EF9CF-8799-2CE0-737B-E00721BB30C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>
            <a:off x="2548958" y="2487252"/>
            <a:ext cx="136488" cy="318298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B65BBF7F-F27F-0AAF-670B-E2FA51F54F0A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60797"/>
          <a:stretch/>
        </p:blipFill>
        <p:spPr>
          <a:xfrm>
            <a:off x="2104141" y="2695576"/>
            <a:ext cx="396274" cy="126672"/>
          </a:xfrm>
          <a:prstGeom prst="rect">
            <a:avLst/>
          </a:prstGeom>
        </p:spPr>
      </p:pic>
      <p:pic>
        <p:nvPicPr>
          <p:cNvPr id="49" name="図 48">
            <a:extLst>
              <a:ext uri="{FF2B5EF4-FFF2-40B4-BE49-F238E27FC236}">
                <a16:creationId xmlns:a16="http://schemas.microsoft.com/office/drawing/2014/main" id="{5647BD63-CA27-89AD-5895-2C3AD7033D8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>
            <a:off x="2102904" y="2491450"/>
            <a:ext cx="136488" cy="318298"/>
          </a:xfrm>
          <a:prstGeom prst="rect">
            <a:avLst/>
          </a:prstGeom>
        </p:spPr>
      </p:pic>
      <p:pic>
        <p:nvPicPr>
          <p:cNvPr id="50" name="図 49">
            <a:extLst>
              <a:ext uri="{FF2B5EF4-FFF2-40B4-BE49-F238E27FC236}">
                <a16:creationId xmlns:a16="http://schemas.microsoft.com/office/drawing/2014/main" id="{C075A2D2-52C7-3314-81B3-189B1FBE30C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 rot="10800000">
            <a:off x="2368854" y="2499741"/>
            <a:ext cx="136488" cy="318298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id="{9CED7603-3606-2B9D-71F5-44185AB2E794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60797"/>
          <a:stretch/>
        </p:blipFill>
        <p:spPr>
          <a:xfrm>
            <a:off x="1678530" y="2695451"/>
            <a:ext cx="396274" cy="126672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id="{3F503D47-DB97-C8AC-C240-890FCF1307E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>
            <a:off x="1677293" y="2491325"/>
            <a:ext cx="136488" cy="318298"/>
          </a:xfrm>
          <a:prstGeom prst="rect">
            <a:avLst/>
          </a:prstGeom>
        </p:spPr>
      </p:pic>
      <p:pic>
        <p:nvPicPr>
          <p:cNvPr id="53" name="図 52">
            <a:extLst>
              <a:ext uri="{FF2B5EF4-FFF2-40B4-BE49-F238E27FC236}">
                <a16:creationId xmlns:a16="http://schemas.microsoft.com/office/drawing/2014/main" id="{E201836F-60D5-6CD7-7BB5-CEB14DBCF46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 rot="10800000">
            <a:off x="1943243" y="2499616"/>
            <a:ext cx="136488" cy="318298"/>
          </a:xfrm>
          <a:prstGeom prst="rect">
            <a:avLst/>
          </a:prstGeom>
        </p:spPr>
      </p:pic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91529D50-26D7-DA8E-ADBA-0F077B14FA86}"/>
              </a:ext>
            </a:extLst>
          </p:cNvPr>
          <p:cNvSpPr/>
          <p:nvPr/>
        </p:nvSpPr>
        <p:spPr>
          <a:xfrm>
            <a:off x="1799991" y="2603915"/>
            <a:ext cx="157041" cy="972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55" name="図 54">
            <a:extLst>
              <a:ext uri="{FF2B5EF4-FFF2-40B4-BE49-F238E27FC236}">
                <a16:creationId xmlns:a16="http://schemas.microsoft.com/office/drawing/2014/main" id="{EFC5142A-CBCE-B91F-E0A5-54C72F41AFFD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60797"/>
          <a:stretch/>
        </p:blipFill>
        <p:spPr>
          <a:xfrm>
            <a:off x="1260280" y="2698513"/>
            <a:ext cx="396274" cy="126672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D4C27D07-BFE1-BEEB-4675-FC5F55984C2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 rot="10800000">
            <a:off x="1524993" y="2504350"/>
            <a:ext cx="136488" cy="318298"/>
          </a:xfrm>
          <a:prstGeom prst="rect">
            <a:avLst/>
          </a:prstGeom>
        </p:spPr>
      </p:pic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F95910BE-C57C-7170-63E1-8CB1A5EFF738}"/>
              </a:ext>
            </a:extLst>
          </p:cNvPr>
          <p:cNvSpPr/>
          <p:nvPr/>
        </p:nvSpPr>
        <p:spPr>
          <a:xfrm>
            <a:off x="1378397" y="2608649"/>
            <a:ext cx="157041" cy="972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58" name="図 57">
            <a:extLst>
              <a:ext uri="{FF2B5EF4-FFF2-40B4-BE49-F238E27FC236}">
                <a16:creationId xmlns:a16="http://schemas.microsoft.com/office/drawing/2014/main" id="{12345F94-3358-3445-1D62-0B740B6C7184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60797"/>
          <a:stretch/>
        </p:blipFill>
        <p:spPr>
          <a:xfrm>
            <a:off x="4345440" y="2684567"/>
            <a:ext cx="396274" cy="126672"/>
          </a:xfrm>
          <a:prstGeom prst="rect">
            <a:avLst/>
          </a:prstGeom>
        </p:spPr>
      </p:pic>
      <p:pic>
        <p:nvPicPr>
          <p:cNvPr id="59" name="図 58">
            <a:extLst>
              <a:ext uri="{FF2B5EF4-FFF2-40B4-BE49-F238E27FC236}">
                <a16:creationId xmlns:a16="http://schemas.microsoft.com/office/drawing/2014/main" id="{E64D9E41-5E4C-45CA-C7E1-749B295AD00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>
            <a:off x="4344203" y="2482710"/>
            <a:ext cx="136488" cy="318298"/>
          </a:xfrm>
          <a:prstGeom prst="rect">
            <a:avLst/>
          </a:prstGeom>
        </p:spPr>
      </p:pic>
      <p:pic>
        <p:nvPicPr>
          <p:cNvPr id="60" name="図 59">
            <a:extLst>
              <a:ext uri="{FF2B5EF4-FFF2-40B4-BE49-F238E27FC236}">
                <a16:creationId xmlns:a16="http://schemas.microsoft.com/office/drawing/2014/main" id="{A2813BC3-37CD-FBF4-D4F7-6502FBD5088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 rot="10800000">
            <a:off x="4610153" y="2491001"/>
            <a:ext cx="136488" cy="318298"/>
          </a:xfrm>
          <a:prstGeom prst="rect">
            <a:avLst/>
          </a:prstGeom>
        </p:spPr>
      </p:pic>
      <p:pic>
        <p:nvPicPr>
          <p:cNvPr id="61" name="図 60">
            <a:extLst>
              <a:ext uri="{FF2B5EF4-FFF2-40B4-BE49-F238E27FC236}">
                <a16:creationId xmlns:a16="http://schemas.microsoft.com/office/drawing/2014/main" id="{A34DC46E-D7CC-E9F1-93FB-EB9DE23AAC6C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60797"/>
          <a:stretch/>
        </p:blipFill>
        <p:spPr>
          <a:xfrm>
            <a:off x="4795658" y="2678545"/>
            <a:ext cx="396274" cy="126672"/>
          </a:xfrm>
          <a:prstGeom prst="rect">
            <a:avLst/>
          </a:prstGeom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BA590A83-F7B3-46D1-C274-8AD6EDA1D12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>
            <a:off x="4794421" y="2474419"/>
            <a:ext cx="136488" cy="318298"/>
          </a:xfrm>
          <a:prstGeom prst="rect">
            <a:avLst/>
          </a:prstGeom>
        </p:spPr>
      </p:pic>
      <p:pic>
        <p:nvPicPr>
          <p:cNvPr id="63" name="図 62">
            <a:extLst>
              <a:ext uri="{FF2B5EF4-FFF2-40B4-BE49-F238E27FC236}">
                <a16:creationId xmlns:a16="http://schemas.microsoft.com/office/drawing/2014/main" id="{1AD41536-AB4A-9A5B-D441-0BEC3428776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-2" r="69001" b="1492"/>
          <a:stretch/>
        </p:blipFill>
        <p:spPr>
          <a:xfrm rot="10800000">
            <a:off x="5060371" y="2482710"/>
            <a:ext cx="136488" cy="318298"/>
          </a:xfrm>
          <a:prstGeom prst="rect">
            <a:avLst/>
          </a:prstGeom>
        </p:spPr>
      </p:pic>
      <p:sp>
        <p:nvSpPr>
          <p:cNvPr id="64" name="正方形/長方形 63">
            <a:extLst>
              <a:ext uri="{FF2B5EF4-FFF2-40B4-BE49-F238E27FC236}">
                <a16:creationId xmlns:a16="http://schemas.microsoft.com/office/drawing/2014/main" id="{016E8D04-4B0D-4F1B-8AAF-4CDD3F070C9F}"/>
              </a:ext>
            </a:extLst>
          </p:cNvPr>
          <p:cNvSpPr/>
          <p:nvPr/>
        </p:nvSpPr>
        <p:spPr>
          <a:xfrm>
            <a:off x="4917119" y="2587009"/>
            <a:ext cx="157041" cy="972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65" name="図 64">
            <a:extLst>
              <a:ext uri="{FF2B5EF4-FFF2-40B4-BE49-F238E27FC236}">
                <a16:creationId xmlns:a16="http://schemas.microsoft.com/office/drawing/2014/main" id="{AECB235D-39C1-0F63-9035-92A7CE512858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60797"/>
          <a:stretch/>
        </p:blipFill>
        <p:spPr>
          <a:xfrm>
            <a:off x="5215703" y="2672173"/>
            <a:ext cx="396274" cy="126672"/>
          </a:xfrm>
          <a:prstGeom prst="rect">
            <a:avLst/>
          </a:prstGeom>
        </p:spPr>
      </p:pic>
      <p:sp>
        <p:nvSpPr>
          <p:cNvPr id="66" name="正方形/長方形 65">
            <a:extLst>
              <a:ext uri="{FF2B5EF4-FFF2-40B4-BE49-F238E27FC236}">
                <a16:creationId xmlns:a16="http://schemas.microsoft.com/office/drawing/2014/main" id="{5C0B4063-57B7-4C92-5D6D-F14372E26B03}"/>
              </a:ext>
            </a:extLst>
          </p:cNvPr>
          <p:cNvSpPr/>
          <p:nvPr/>
        </p:nvSpPr>
        <p:spPr>
          <a:xfrm>
            <a:off x="5333820" y="2582309"/>
            <a:ext cx="157041" cy="972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3886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</TotalTime>
  <Words>43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entury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秋友　達哉</dc:creator>
  <cp:lastModifiedBy>MDPI</cp:lastModifiedBy>
  <cp:revision>7</cp:revision>
  <dcterms:created xsi:type="dcterms:W3CDTF">2025-02-13T03:35:47Z</dcterms:created>
  <dcterms:modified xsi:type="dcterms:W3CDTF">2025-02-19T13:35:47Z</dcterms:modified>
</cp:coreProperties>
</file>